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5E41703-9ABC-5E2D-E46A-C0462F39C6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2029" y="1344166"/>
            <a:ext cx="2275697" cy="224339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179CD23-6671-102F-C1E8-9D49A3ABAD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7446" y="1258813"/>
            <a:ext cx="2623433" cy="24265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CC71FEC-3FDA-97F4-3669-BE179983EB3B}"/>
              </a:ext>
            </a:extLst>
          </p:cNvPr>
          <p:cNvSpPr txBox="1"/>
          <p:nvPr/>
        </p:nvSpPr>
        <p:spPr>
          <a:xfrm>
            <a:off x="189941" y="3984140"/>
            <a:ext cx="6478117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068705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TGF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1 expression is present in the immune cell compartment of human Ewing tumors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pression of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1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GFB1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in cell populations from analyzed </a:t>
            </a:r>
            <a:r>
              <a:rPr lang="en-US" sz="1100" kern="100" dirty="0" err="1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cRNA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eq data. In four human Ewing sarcomas (left panel), all cells present in the tumor underwent </a:t>
            </a:r>
            <a:r>
              <a:rPr lang="en-US" sz="1100" kern="100" dirty="0" err="1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cRNA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eq. In three human Ewing sarcomas (right panel) CD45+ cells only were isolated and subjected to </a:t>
            </a:r>
            <a:r>
              <a:rPr lang="en-US" sz="1100" kern="100" dirty="0" err="1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cRNA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eq to enrich the number of immune cell analyzed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071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7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5:54Z</dcterms:modified>
</cp:coreProperties>
</file>